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096964576117194"/>
          <c:y val="0.13768832925484978"/>
          <c:w val="0.8796374390153896"/>
          <c:h val="0.70025207089788477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yVal>
            <c:numRef>
              <c:f>Table!$L$65:$P$65</c:f>
              <c:numCache>
                <c:formatCode>General</c:formatCode>
                <c:ptCount val="5"/>
                <c:pt idx="0">
                  <c:v>0</c:v>
                </c:pt>
                <c:pt idx="1">
                  <c:v>0.24399999999999999</c:v>
                </c:pt>
                <c:pt idx="2">
                  <c:v>0.34799999999999998</c:v>
                </c:pt>
                <c:pt idx="3">
                  <c:v>0.50900000000000001</c:v>
                </c:pt>
                <c:pt idx="4">
                  <c:v>0.697000000000000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180-4DF7-A064-87FB574ED6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2969728"/>
        <c:axId val="782964808"/>
      </c:scatterChart>
      <c:valAx>
        <c:axId val="782969728"/>
        <c:scaling>
          <c:orientation val="minMax"/>
          <c:max val="5"/>
          <c:min val="1"/>
        </c:scaling>
        <c:delete val="0"/>
        <c:axPos val="b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2964808"/>
        <c:crosses val="autoZero"/>
        <c:crossBetween val="midCat"/>
      </c:valAx>
      <c:valAx>
        <c:axId val="782964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2969728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C$6</c:f>
              <c:strCache>
                <c:ptCount val="1"/>
                <c:pt idx="0">
                  <c:v>B2 1/15 R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Sheet1!$B$7:$B$47</c:f>
              <c:numCache>
                <c:formatCode>General</c:formatCode>
                <c:ptCount val="4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Sheet1!$C$7:$C$47</c:f>
              <c:numCache>
                <c:formatCode>General</c:formatCode>
                <c:ptCount val="41"/>
                <c:pt idx="0">
                  <c:v>0</c:v>
                </c:pt>
                <c:pt idx="1">
                  <c:v>5.8000000000000052E-2</c:v>
                </c:pt>
                <c:pt idx="2">
                  <c:v>0.11800000000000033</c:v>
                </c:pt>
                <c:pt idx="3">
                  <c:v>0.20199999999999996</c:v>
                </c:pt>
                <c:pt idx="4">
                  <c:v>0.23299999999999987</c:v>
                </c:pt>
                <c:pt idx="5">
                  <c:v>0.29099999999999993</c:v>
                </c:pt>
                <c:pt idx="6">
                  <c:v>0.33100000000000018</c:v>
                </c:pt>
                <c:pt idx="7">
                  <c:v>0.38300000000000023</c:v>
                </c:pt>
                <c:pt idx="8">
                  <c:v>0.42000000000000015</c:v>
                </c:pt>
                <c:pt idx="9">
                  <c:v>0.45199999999999974</c:v>
                </c:pt>
                <c:pt idx="10">
                  <c:v>0.50400000000000023</c:v>
                </c:pt>
                <c:pt idx="11">
                  <c:v>0.52600000000000025</c:v>
                </c:pt>
                <c:pt idx="12">
                  <c:v>0.54400000000000004</c:v>
                </c:pt>
                <c:pt idx="13">
                  <c:v>0.55199999999999982</c:v>
                </c:pt>
                <c:pt idx="14">
                  <c:v>0.58699999999999974</c:v>
                </c:pt>
                <c:pt idx="15">
                  <c:v>0.60400000000000009</c:v>
                </c:pt>
                <c:pt idx="16">
                  <c:v>0.62900000000000023</c:v>
                </c:pt>
                <c:pt idx="17">
                  <c:v>0.63600000000000012</c:v>
                </c:pt>
                <c:pt idx="18">
                  <c:v>0.67100000000000004</c:v>
                </c:pt>
                <c:pt idx="19">
                  <c:v>0.68200000000000016</c:v>
                </c:pt>
                <c:pt idx="20">
                  <c:v>0.70000000000000018</c:v>
                </c:pt>
                <c:pt idx="21">
                  <c:v>0.71400000000000019</c:v>
                </c:pt>
                <c:pt idx="22">
                  <c:v>0.73600000000000021</c:v>
                </c:pt>
                <c:pt idx="23">
                  <c:v>0.72599999999999998</c:v>
                </c:pt>
                <c:pt idx="24">
                  <c:v>0.752</c:v>
                </c:pt>
                <c:pt idx="25">
                  <c:v>0.77900000000000014</c:v>
                </c:pt>
                <c:pt idx="26">
                  <c:v>0.77400000000000024</c:v>
                </c:pt>
                <c:pt idx="27">
                  <c:v>0.77699999999999991</c:v>
                </c:pt>
                <c:pt idx="28">
                  <c:v>0.78600000000000003</c:v>
                </c:pt>
                <c:pt idx="29">
                  <c:v>0.78299999999999992</c:v>
                </c:pt>
                <c:pt idx="30">
                  <c:v>0.78700000000000014</c:v>
                </c:pt>
                <c:pt idx="31">
                  <c:v>0.81700000000000017</c:v>
                </c:pt>
                <c:pt idx="32">
                  <c:v>0.81699999999999995</c:v>
                </c:pt>
                <c:pt idx="33">
                  <c:v>0.82099999999999995</c:v>
                </c:pt>
                <c:pt idx="34">
                  <c:v>0.84200000000000008</c:v>
                </c:pt>
                <c:pt idx="35">
                  <c:v>0.84299999999999997</c:v>
                </c:pt>
                <c:pt idx="36">
                  <c:v>0.82499999999999996</c:v>
                </c:pt>
                <c:pt idx="37">
                  <c:v>0.84800000000000009</c:v>
                </c:pt>
                <c:pt idx="38">
                  <c:v>0.84899999999999998</c:v>
                </c:pt>
                <c:pt idx="39">
                  <c:v>0.87500000000000022</c:v>
                </c:pt>
                <c:pt idx="40">
                  <c:v>0.865000000000000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904-450D-A2AA-58B369D6D5E1}"/>
            </c:ext>
          </c:extLst>
        </c:ser>
        <c:ser>
          <c:idx val="1"/>
          <c:order val="1"/>
          <c:tx>
            <c:strRef>
              <c:f>Sheet1!$D$6</c:f>
              <c:strCache>
                <c:ptCount val="1"/>
                <c:pt idx="0">
                  <c:v>B2 1/33 RAN</c:v>
                </c:pt>
              </c:strCache>
            </c:strRef>
          </c:tx>
          <c:spPr>
            <a:ln w="28575" cap="rnd">
              <a:solidFill>
                <a:srgbClr val="2113DB"/>
              </a:solidFill>
              <a:round/>
            </a:ln>
            <a:effectLst/>
          </c:spPr>
          <c:marker>
            <c:symbol val="none"/>
          </c:marker>
          <c:xVal>
            <c:numRef>
              <c:f>Sheet1!$B$7:$B$47</c:f>
              <c:numCache>
                <c:formatCode>General</c:formatCode>
                <c:ptCount val="4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Sheet1!$D$7:$D$47</c:f>
              <c:numCache>
                <c:formatCode>General</c:formatCode>
                <c:ptCount val="41"/>
                <c:pt idx="0">
                  <c:v>0</c:v>
                </c:pt>
                <c:pt idx="1">
                  <c:v>2.4000000000000021E-2</c:v>
                </c:pt>
                <c:pt idx="2">
                  <c:v>5.600000000000005E-2</c:v>
                </c:pt>
                <c:pt idx="3">
                  <c:v>9.199999999999986E-2</c:v>
                </c:pt>
                <c:pt idx="4">
                  <c:v>0.12299999999999978</c:v>
                </c:pt>
                <c:pt idx="5">
                  <c:v>0.16300000000000003</c:v>
                </c:pt>
                <c:pt idx="6">
                  <c:v>0.19199999999999973</c:v>
                </c:pt>
                <c:pt idx="7">
                  <c:v>0.21700000000000008</c:v>
                </c:pt>
                <c:pt idx="8">
                  <c:v>0.2330000000000001</c:v>
                </c:pt>
                <c:pt idx="9">
                  <c:v>0.24500000000000011</c:v>
                </c:pt>
                <c:pt idx="10">
                  <c:v>0.26100000000000012</c:v>
                </c:pt>
                <c:pt idx="11">
                  <c:v>0.29600000000000004</c:v>
                </c:pt>
                <c:pt idx="12">
                  <c:v>0.28199999999999981</c:v>
                </c:pt>
                <c:pt idx="13">
                  <c:v>0.28399999999999981</c:v>
                </c:pt>
                <c:pt idx="14">
                  <c:v>0.30899999999999994</c:v>
                </c:pt>
                <c:pt idx="15">
                  <c:v>0.30099999999999993</c:v>
                </c:pt>
                <c:pt idx="16">
                  <c:v>0.33099999999999996</c:v>
                </c:pt>
                <c:pt idx="17">
                  <c:v>0.32599999999999985</c:v>
                </c:pt>
                <c:pt idx="18">
                  <c:v>0.3490000000000002</c:v>
                </c:pt>
                <c:pt idx="19">
                  <c:v>0.33999999999999986</c:v>
                </c:pt>
                <c:pt idx="20">
                  <c:v>0.34599999999999986</c:v>
                </c:pt>
                <c:pt idx="21">
                  <c:v>0.35499999999999998</c:v>
                </c:pt>
                <c:pt idx="22">
                  <c:v>0.36700000000000021</c:v>
                </c:pt>
                <c:pt idx="23">
                  <c:v>0.3680000000000001</c:v>
                </c:pt>
                <c:pt idx="24">
                  <c:v>0.3879999999999999</c:v>
                </c:pt>
                <c:pt idx="25">
                  <c:v>0.375</c:v>
                </c:pt>
                <c:pt idx="26">
                  <c:v>0.38900000000000023</c:v>
                </c:pt>
                <c:pt idx="27">
                  <c:v>0.375</c:v>
                </c:pt>
                <c:pt idx="28">
                  <c:v>0.38900000000000001</c:v>
                </c:pt>
                <c:pt idx="29">
                  <c:v>0.38900000000000001</c:v>
                </c:pt>
                <c:pt idx="30">
                  <c:v>0.38099999999999978</c:v>
                </c:pt>
                <c:pt idx="31">
                  <c:v>0.38500000000000001</c:v>
                </c:pt>
                <c:pt idx="32">
                  <c:v>0.40899999999999981</c:v>
                </c:pt>
                <c:pt idx="33">
                  <c:v>0.40300000000000002</c:v>
                </c:pt>
                <c:pt idx="34">
                  <c:v>0.40900000000000003</c:v>
                </c:pt>
                <c:pt idx="35">
                  <c:v>0.40199999999999991</c:v>
                </c:pt>
                <c:pt idx="36">
                  <c:v>0.40399999999999991</c:v>
                </c:pt>
                <c:pt idx="37">
                  <c:v>0.39800000000000013</c:v>
                </c:pt>
                <c:pt idx="38">
                  <c:v>0.40700000000000003</c:v>
                </c:pt>
                <c:pt idx="39">
                  <c:v>0.40700000000000003</c:v>
                </c:pt>
                <c:pt idx="40">
                  <c:v>0.40500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904-450D-A2AA-58B369D6D5E1}"/>
            </c:ext>
          </c:extLst>
        </c:ser>
        <c:ser>
          <c:idx val="2"/>
          <c:order val="2"/>
          <c:tx>
            <c:strRef>
              <c:f>Sheet1!$E$6</c:f>
              <c:strCache>
                <c:ptCount val="1"/>
                <c:pt idx="0">
                  <c:v>B2 1/50 RAN</c:v>
                </c:pt>
              </c:strCache>
            </c:strRef>
          </c:tx>
          <c:spPr>
            <a:ln w="28575" cap="rnd">
              <a:solidFill>
                <a:srgbClr val="5A4EF0"/>
              </a:solidFill>
              <a:round/>
            </a:ln>
            <a:effectLst/>
          </c:spPr>
          <c:marker>
            <c:symbol val="none"/>
          </c:marker>
          <c:xVal>
            <c:numRef>
              <c:f>Sheet1!$B$7:$B$47</c:f>
              <c:numCache>
                <c:formatCode>General</c:formatCode>
                <c:ptCount val="4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Sheet1!$E$7:$E$47</c:f>
              <c:numCache>
                <c:formatCode>General</c:formatCode>
                <c:ptCount val="41"/>
                <c:pt idx="0">
                  <c:v>0</c:v>
                </c:pt>
                <c:pt idx="1">
                  <c:v>4.0000000000002256E-3</c:v>
                </c:pt>
                <c:pt idx="2">
                  <c:v>-1.1999999999999789E-2</c:v>
                </c:pt>
                <c:pt idx="3">
                  <c:v>-1.4999999999999902E-2</c:v>
                </c:pt>
                <c:pt idx="4">
                  <c:v>-2.5999999999999801E-2</c:v>
                </c:pt>
                <c:pt idx="5">
                  <c:v>-2.9999999999999805E-2</c:v>
                </c:pt>
                <c:pt idx="6">
                  <c:v>-9.9999999999997868E-3</c:v>
                </c:pt>
                <c:pt idx="7">
                  <c:v>-1.8999999999999684E-2</c:v>
                </c:pt>
                <c:pt idx="8">
                  <c:v>-4.0000000000000036E-3</c:v>
                </c:pt>
                <c:pt idx="9">
                  <c:v>-1.4999999999999902E-2</c:v>
                </c:pt>
                <c:pt idx="10">
                  <c:v>-1.9999999999999796E-2</c:v>
                </c:pt>
                <c:pt idx="11">
                  <c:v>-1.0999999999999899E-2</c:v>
                </c:pt>
                <c:pt idx="12">
                  <c:v>-3.6000000000000032E-2</c:v>
                </c:pt>
                <c:pt idx="13">
                  <c:v>-5.0999999999999934E-2</c:v>
                </c:pt>
                <c:pt idx="14">
                  <c:v>-1.2000000000000011E-2</c:v>
                </c:pt>
                <c:pt idx="15">
                  <c:v>-3.8999999999999924E-2</c:v>
                </c:pt>
                <c:pt idx="16">
                  <c:v>-2.0999999999999686E-2</c:v>
                </c:pt>
                <c:pt idx="17">
                  <c:v>-4.8999999999999932E-2</c:v>
                </c:pt>
                <c:pt idx="18">
                  <c:v>-2.8999999999999693E-2</c:v>
                </c:pt>
                <c:pt idx="19">
                  <c:v>-3.599999999999981E-2</c:v>
                </c:pt>
                <c:pt idx="20">
                  <c:v>-2.3999999999999799E-2</c:v>
                </c:pt>
                <c:pt idx="21">
                  <c:v>-3.3999999999999808E-2</c:v>
                </c:pt>
                <c:pt idx="22">
                  <c:v>-2.0999999999999686E-2</c:v>
                </c:pt>
                <c:pt idx="23">
                  <c:v>-3.0999999999999694E-2</c:v>
                </c:pt>
                <c:pt idx="24">
                  <c:v>-2.1999999999999797E-2</c:v>
                </c:pt>
                <c:pt idx="25">
                  <c:v>-2.7999999999999803E-2</c:v>
                </c:pt>
                <c:pt idx="26">
                  <c:v>-3.9999999999999813E-2</c:v>
                </c:pt>
                <c:pt idx="27">
                  <c:v>-1.5999999999999792E-2</c:v>
                </c:pt>
                <c:pt idx="28">
                  <c:v>-2.8999999999999693E-2</c:v>
                </c:pt>
                <c:pt idx="29">
                  <c:v>-3.8999999999999924E-2</c:v>
                </c:pt>
                <c:pt idx="30">
                  <c:v>-4.9999999999999822E-2</c:v>
                </c:pt>
                <c:pt idx="31">
                  <c:v>-4.3999999999999817E-2</c:v>
                </c:pt>
                <c:pt idx="32">
                  <c:v>-3.3999999999999808E-2</c:v>
                </c:pt>
                <c:pt idx="33">
                  <c:v>-4.9999999999999822E-2</c:v>
                </c:pt>
                <c:pt idx="34">
                  <c:v>-3.7999999999999812E-2</c:v>
                </c:pt>
                <c:pt idx="35">
                  <c:v>-2.3999999999999799E-2</c:v>
                </c:pt>
                <c:pt idx="36">
                  <c:v>-3.0999999999999917E-2</c:v>
                </c:pt>
                <c:pt idx="37">
                  <c:v>-3.599999999999981E-2</c:v>
                </c:pt>
                <c:pt idx="38">
                  <c:v>-3.9999999999999813E-2</c:v>
                </c:pt>
                <c:pt idx="39">
                  <c:v>-3.1999999999999806E-2</c:v>
                </c:pt>
                <c:pt idx="40">
                  <c:v>-5.8999999999999941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904-450D-A2AA-58B369D6D5E1}"/>
            </c:ext>
          </c:extLst>
        </c:ser>
        <c:ser>
          <c:idx val="3"/>
          <c:order val="3"/>
          <c:tx>
            <c:strRef>
              <c:f>Sheet1!$F$6</c:f>
              <c:strCache>
                <c:ptCount val="1"/>
                <c:pt idx="0">
                  <c:v>B2 O RAN</c:v>
                </c:pt>
              </c:strCache>
            </c:strRef>
          </c:tx>
          <c:spPr>
            <a:ln w="19050" cap="rnd">
              <a:solidFill>
                <a:srgbClr val="3399FF"/>
              </a:solidFill>
              <a:round/>
            </a:ln>
            <a:effectLst/>
          </c:spPr>
          <c:marker>
            <c:symbol val="none"/>
          </c:marker>
          <c:xVal>
            <c:numRef>
              <c:f>Sheet1!$B$7:$B$47</c:f>
              <c:numCache>
                <c:formatCode>General</c:formatCode>
                <c:ptCount val="4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xVal>
          <c:yVal>
            <c:numRef>
              <c:f>Sheet1!$F$7:$F$47</c:f>
              <c:numCache>
                <c:formatCode>General</c:formatCode>
                <c:ptCount val="4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904-450D-A2AA-58B369D6D5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9479488"/>
        <c:axId val="209479816"/>
      </c:scatterChart>
      <c:valAx>
        <c:axId val="209479488"/>
        <c:scaling>
          <c:orientation val="minMax"/>
          <c:max val="40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9479816"/>
        <c:crosses val="autoZero"/>
        <c:crossBetween val="midCat"/>
        <c:majorUnit val="10"/>
      </c:valAx>
      <c:valAx>
        <c:axId val="209479816"/>
        <c:scaling>
          <c:orientation val="minMax"/>
          <c:max val="0.9"/>
          <c:min val="-0.1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9479488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3DBFE0-DEFB-883C-FB44-8F5EB95CDD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E4B4E3-CEB2-DE6F-132D-43019F7083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03C8C7-C1C4-0E7C-FE88-868BCF675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88020A-9F7E-CC7B-C0E4-86CB7C0F1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8AF945-5148-7153-A108-AB00CE120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027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9B550-0CE4-79E7-E54B-DBA66AC476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8F83DF-3756-BBAD-5FAB-232BB085CA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ABE989-CA5A-2FB5-8016-A14E3213E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4A7904-22DF-6AA4-DA39-D804CDCC0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2DB24-97E0-921D-7487-BE7C17269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5685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E555C5-56A9-1D90-4367-B0C90E499B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3C239E-1867-A5CD-AB58-B6090CA949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55F172-0F2D-AAB8-63BB-BC024AF82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2DA096-A4EC-F617-8A04-2356A47DE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DDFB6-6C69-7E90-514E-87E5BB7CD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7302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F2F8D-5308-F25B-5F98-38A5D179E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ACD550-36E7-E976-A871-0CA9281017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8BF2E-2A8C-A67B-C117-914B8B22B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B512B7-2413-B7BA-C021-CA882BA80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805CA6-CDB7-4695-342D-4C8E7A32A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5307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E389AB-05D9-A736-0FA7-488ABA770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96C668-F645-D0F4-AB25-B5028DF316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BDE82B-60C2-7D15-D6AF-2D0BE013B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1644C0-19F9-D84D-DE3A-33BD9BD47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52D049-0C26-9C38-9746-25470763E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4925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12E70-E4AC-FFBD-0FDB-48E9542770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6E6D47-0742-AEB3-BF72-26E34B0B31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E66C7D-2431-5A39-8DAE-B047C2A79C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9DC9BA-D9C1-C498-2E0E-AFA9952BB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424773-85B0-2F60-B9F3-CBA3F676B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C6543B-3B16-9640-1193-A179658BC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6148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7DD375-18F8-E5CA-07C4-ED8EA56FEE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388A6F-8964-AB05-2D6B-F48F5F9C4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36E2DD-D94B-F0C8-E06B-881F780743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52715A-7F3C-D46A-21F9-CAF6242987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02F815-849B-4BC0-E636-9FB1E74661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C11360-A688-7E26-1355-841726584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EB31D5-4782-91E5-A4AF-6BC9444E7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E5E3F4-B81D-59B3-FC6A-81CEE6989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5041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DB30B-1326-5417-8D1F-0D0F6F6525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98065C-1AFD-BBCA-3E99-29C3FB29E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2656A5-5B0E-8572-A983-12FAEDB3C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874459-F095-84C0-072A-02FE6F1D3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2958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357002-9A29-77B7-A092-173674400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747D6C6-7A18-5E0C-628D-2F6B7BA0F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157CD9-AE04-9588-3796-615B6F125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5414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0475FD-9BEB-D89E-42E5-AC0D8B6061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115EAC-1BB4-BA28-A185-DC8F2F442C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15E530-BC1E-E844-736E-EBF53F332B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5A25D1-6FDE-86AC-7D40-EB72BABA4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89AABC-23F7-093E-54C2-A595188EF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C090C9-E146-EB0A-1C61-19E4825E6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962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974BB-B541-8316-A786-D11248A64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9DC358-AA24-CE8E-C2C8-E26CB84548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FE2EC8-C853-5C18-DC92-4B5246A326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C2B778-0A41-BC68-CFF7-8CD36BA7F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86FFDB-446A-4179-94A3-5767C91BA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F078A2-8D36-0504-1784-3835835D4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0678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557F5E-C1C8-27B4-B666-239DC81083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FBC8EE-208A-2FED-E44C-04E47BBEEF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48C35B-B397-E55A-3C1B-68D1F88422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88D56-B6E0-4BE8-9D58-B340A7BBB2FC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A437E0-EA4B-592A-F2B8-D0E9E31076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B9DDD6-9279-6D7E-C9C8-8F25AD6808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F0FB9-28B0-4169-9D17-BA455EBDF0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348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896149E8-CD2F-44D4-9907-7A2295901D88}"/>
              </a:ext>
            </a:extLst>
          </p:cNvPr>
          <p:cNvSpPr txBox="1"/>
          <p:nvPr/>
        </p:nvSpPr>
        <p:spPr>
          <a:xfrm rot="16200000">
            <a:off x="2035398" y="689404"/>
            <a:ext cx="22096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bsorbance (360nm)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1A7C38B9-F24A-2AAC-6201-53FC5B4F98F1}"/>
              </a:ext>
            </a:extLst>
          </p:cNvPr>
          <p:cNvGrpSpPr/>
          <p:nvPr/>
        </p:nvGrpSpPr>
        <p:grpSpPr>
          <a:xfrm>
            <a:off x="2708374" y="282262"/>
            <a:ext cx="5985322" cy="4544987"/>
            <a:chOff x="2708374" y="626211"/>
            <a:chExt cx="5985322" cy="4544987"/>
          </a:xfrm>
        </p:grpSpPr>
        <p:graphicFrame>
          <p:nvGraphicFramePr>
            <p:cNvPr id="16" name="Chart 15">
              <a:extLst>
                <a:ext uri="{FF2B5EF4-FFF2-40B4-BE49-F238E27FC236}">
                  <a16:creationId xmlns:a16="http://schemas.microsoft.com/office/drawing/2014/main" id="{57F25714-D8E4-4F89-8C80-9402E1A305F1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320940" y="626211"/>
            <a:ext cx="2207977" cy="19138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569BF07-2827-4A89-96C0-3A0FAB3DACE8}"/>
                </a:ext>
              </a:extLst>
            </p:cNvPr>
            <p:cNvSpPr txBox="1"/>
            <p:nvPr/>
          </p:nvSpPr>
          <p:spPr>
            <a:xfrm>
              <a:off x="3476773" y="2199720"/>
              <a:ext cx="263214" cy="409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A79B11A-2E24-43C6-870D-649A1EECF29C}"/>
                </a:ext>
              </a:extLst>
            </p:cNvPr>
            <p:cNvSpPr txBox="1"/>
            <p:nvPr/>
          </p:nvSpPr>
          <p:spPr>
            <a:xfrm>
              <a:off x="3955912" y="2199720"/>
              <a:ext cx="263214" cy="409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6260E4E-3D70-4A1A-9AD1-E1AF2C3FD701}"/>
                </a:ext>
              </a:extLst>
            </p:cNvPr>
            <p:cNvSpPr txBox="1"/>
            <p:nvPr/>
          </p:nvSpPr>
          <p:spPr>
            <a:xfrm>
              <a:off x="4435051" y="2199720"/>
              <a:ext cx="263214" cy="409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212B4FF-F27F-491E-A690-F8789BD92C8A}"/>
                </a:ext>
              </a:extLst>
            </p:cNvPr>
            <p:cNvSpPr txBox="1"/>
            <p:nvPr/>
          </p:nvSpPr>
          <p:spPr>
            <a:xfrm>
              <a:off x="4914190" y="2199720"/>
              <a:ext cx="263214" cy="409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3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E1851A2-E55E-4BBF-AD14-EB55AB3FF547}"/>
                </a:ext>
              </a:extLst>
            </p:cNvPr>
            <p:cNvSpPr txBox="1"/>
            <p:nvPr/>
          </p:nvSpPr>
          <p:spPr>
            <a:xfrm>
              <a:off x="5393330" y="2199720"/>
              <a:ext cx="263214" cy="409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4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23A892D-5725-4713-9033-16DF54612B44}"/>
                </a:ext>
              </a:extLst>
            </p:cNvPr>
            <p:cNvSpPr txBox="1"/>
            <p:nvPr/>
          </p:nvSpPr>
          <p:spPr>
            <a:xfrm>
              <a:off x="4176648" y="2438428"/>
              <a:ext cx="639919" cy="409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[Pi] </a:t>
              </a:r>
              <a:r>
                <a:rPr lang="en-GB" sz="1200" dirty="0" err="1"/>
                <a:t>uM</a:t>
              </a:r>
              <a:endParaRPr lang="en-GB" sz="1200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F63A31F-9836-4584-9AF2-6B9A71AC64BA}"/>
                </a:ext>
              </a:extLst>
            </p:cNvPr>
            <p:cNvSpPr txBox="1"/>
            <p:nvPr/>
          </p:nvSpPr>
          <p:spPr>
            <a:xfrm>
              <a:off x="2708374" y="672387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A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7A2BC12-D753-4525-B643-4E9A7B5B9D0A}"/>
                </a:ext>
              </a:extLst>
            </p:cNvPr>
            <p:cNvSpPr txBox="1"/>
            <p:nvPr/>
          </p:nvSpPr>
          <p:spPr>
            <a:xfrm>
              <a:off x="2708374" y="2798874"/>
              <a:ext cx="40394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dirty="0"/>
                <a:t>C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F44BF20-19B5-4ED1-BBFF-CDC7A0F3C79C}"/>
                </a:ext>
              </a:extLst>
            </p:cNvPr>
            <p:cNvSpPr txBox="1"/>
            <p:nvPr/>
          </p:nvSpPr>
          <p:spPr>
            <a:xfrm>
              <a:off x="5858158" y="672387"/>
              <a:ext cx="42756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dirty="0"/>
                <a:t>B</a:t>
              </a:r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460BE8EB-329D-473F-B279-99241C1AD7ED}"/>
                </a:ext>
              </a:extLst>
            </p:cNvPr>
            <p:cNvGrpSpPr/>
            <p:nvPr/>
          </p:nvGrpSpPr>
          <p:grpSpPr>
            <a:xfrm>
              <a:off x="6096000" y="1332180"/>
              <a:ext cx="2032622" cy="1483431"/>
              <a:chOff x="9696422" y="1098377"/>
              <a:chExt cx="2032622" cy="1483431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24285155-5F41-49B0-B624-63F1979AAE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 rot="16200000">
                <a:off x="11450575" y="1147283"/>
                <a:ext cx="327376" cy="229563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3D3C85A-153D-4248-B8AE-8C42E8C1DB3C}"/>
                  </a:ext>
                </a:extLst>
              </p:cNvPr>
              <p:cNvSpPr txBox="1"/>
              <p:nvPr/>
            </p:nvSpPr>
            <p:spPr>
              <a:xfrm rot="16200000">
                <a:off x="9274456" y="1852794"/>
                <a:ext cx="11810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ytoPlxnB1(WT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B4A55BC-F90A-4D76-A244-8D88C8FF9AA8}"/>
                  </a:ext>
                </a:extLst>
              </p:cNvPr>
              <p:cNvSpPr txBox="1"/>
              <p:nvPr/>
            </p:nvSpPr>
            <p:spPr>
              <a:xfrm rot="16200000">
                <a:off x="9659217" y="1833558"/>
                <a:ext cx="11425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ytoPlxnB1(RA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1CB9DED-7B5C-4FDB-83A8-C73BB34F6800}"/>
                  </a:ext>
                </a:extLst>
              </p:cNvPr>
              <p:cNvSpPr txBox="1"/>
              <p:nvPr/>
            </p:nvSpPr>
            <p:spPr>
              <a:xfrm rot="16200000">
                <a:off x="10122467" y="1700509"/>
                <a:ext cx="8764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ytoPlxnB2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733EDAA-4A0C-4941-910B-67ABCE5C7D4E}"/>
                  </a:ext>
                </a:extLst>
              </p:cNvPr>
              <p:cNvSpPr txBox="1"/>
              <p:nvPr/>
            </p:nvSpPr>
            <p:spPr>
              <a:xfrm rot="16200000">
                <a:off x="10381482" y="1700509"/>
                <a:ext cx="8764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ytoPlxnB3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20FCEBE-4E6D-4264-83D7-62CB1C9F7E18}"/>
                  </a:ext>
                </a:extLst>
              </p:cNvPr>
              <p:cNvSpPr txBox="1"/>
              <p:nvPr/>
            </p:nvSpPr>
            <p:spPr>
              <a:xfrm rot="16200000">
                <a:off x="10788385" y="1646359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RanGAP1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3F98FDB-5945-4C4D-9093-8DF2F097575E}"/>
                  </a:ext>
                </a:extLst>
              </p:cNvPr>
              <p:cNvSpPr txBox="1"/>
              <p:nvPr/>
            </p:nvSpPr>
            <p:spPr>
              <a:xfrm rot="16200000">
                <a:off x="11379589" y="1473235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Ran</a:t>
                </a:r>
              </a:p>
            </p:txBody>
          </p:sp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D4326584-0E28-4471-866D-69D5B5D65E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696422" y="1104654"/>
                <a:ext cx="1755622" cy="329609"/>
              </a:xfrm>
              <a:prstGeom prst="rect">
                <a:avLst/>
              </a:prstGeom>
            </p:spPr>
          </p:pic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326237CE-40A8-4016-90D9-9FD5F0DD23BF}"/>
                </a:ext>
              </a:extLst>
            </p:cNvPr>
            <p:cNvGrpSpPr/>
            <p:nvPr/>
          </p:nvGrpSpPr>
          <p:grpSpPr>
            <a:xfrm>
              <a:off x="3069246" y="3055933"/>
              <a:ext cx="5624450" cy="2115265"/>
              <a:chOff x="727575" y="2059850"/>
              <a:chExt cx="5624450" cy="2115265"/>
            </a:xfrm>
          </p:grpSpPr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AD18B4D-ED3A-4767-B03F-87CFE17BED8D}"/>
                  </a:ext>
                </a:extLst>
              </p:cNvPr>
              <p:cNvSpPr txBox="1"/>
              <p:nvPr/>
            </p:nvSpPr>
            <p:spPr>
              <a:xfrm>
                <a:off x="4289439" y="2113533"/>
                <a:ext cx="1502360" cy="262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PlxnB2(WT)+15.3uMRan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E3B4010-8F44-432F-95AA-C35BDAFFFA31}"/>
                  </a:ext>
                </a:extLst>
              </p:cNvPr>
              <p:cNvSpPr txBox="1"/>
              <p:nvPr/>
            </p:nvSpPr>
            <p:spPr>
              <a:xfrm>
                <a:off x="4289439" y="2825010"/>
                <a:ext cx="1735240" cy="2629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dirty="0"/>
                  <a:t>PlxnB2(WT)+6.9uMRan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225F749-3D4D-4F08-85ED-6510D245DA1D}"/>
                  </a:ext>
                </a:extLst>
              </p:cNvPr>
              <p:cNvSpPr txBox="1"/>
              <p:nvPr/>
            </p:nvSpPr>
            <p:spPr>
              <a:xfrm>
                <a:off x="4289439" y="3599511"/>
                <a:ext cx="2062586" cy="2629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dirty="0"/>
                  <a:t>PlxnB2(WT)+4.6uMRan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FE0FB5A5-0515-4B32-B407-1C2B54030BEB}"/>
                  </a:ext>
                </a:extLst>
              </p:cNvPr>
              <p:cNvSpPr txBox="1"/>
              <p:nvPr/>
            </p:nvSpPr>
            <p:spPr>
              <a:xfrm>
                <a:off x="4289439" y="3457484"/>
                <a:ext cx="550754" cy="262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control</a:t>
                </a:r>
              </a:p>
            </p:txBody>
          </p:sp>
          <p:graphicFrame>
            <p:nvGraphicFramePr>
              <p:cNvPr id="32" name="Chart 31">
                <a:extLst>
                  <a:ext uri="{FF2B5EF4-FFF2-40B4-BE49-F238E27FC236}">
                    <a16:creationId xmlns:a16="http://schemas.microsoft.com/office/drawing/2014/main" id="{F8633881-7CC4-455E-945D-4E380972D9A7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149183" y="2059850"/>
              <a:ext cx="3346155" cy="183121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66D602DA-ACA6-4099-A008-137217E9F09F}"/>
                  </a:ext>
                </a:extLst>
              </p:cNvPr>
              <p:cNvSpPr txBox="1"/>
              <p:nvPr/>
            </p:nvSpPr>
            <p:spPr>
              <a:xfrm>
                <a:off x="2799700" y="3912169"/>
                <a:ext cx="989770" cy="2629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Time (seconds)</a:t>
                </a:r>
              </a:p>
            </p:txBody>
          </p: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2519C792-8221-4293-A8E5-E63D1CF3E154}"/>
                  </a:ext>
                </a:extLst>
              </p:cNvPr>
              <p:cNvGrpSpPr/>
              <p:nvPr/>
            </p:nvGrpSpPr>
            <p:grpSpPr>
              <a:xfrm>
                <a:off x="1131616" y="3714403"/>
                <a:ext cx="3435555" cy="248338"/>
                <a:chOff x="6411038" y="4840697"/>
                <a:chExt cx="3919369" cy="261610"/>
              </a:xfrm>
            </p:grpSpPr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ACC4CCC7-A2FE-425D-A69D-E41B49845FDD}"/>
                    </a:ext>
                  </a:extLst>
                </p:cNvPr>
                <p:cNvSpPr txBox="1"/>
                <p:nvPr/>
              </p:nvSpPr>
              <p:spPr>
                <a:xfrm>
                  <a:off x="7252888" y="4840697"/>
                  <a:ext cx="40107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dirty="0"/>
                    <a:t>100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5A16F576-CCDC-42F2-90D3-F460E1E39F16}"/>
                    </a:ext>
                  </a:extLst>
                </p:cNvPr>
                <p:cNvSpPr txBox="1"/>
                <p:nvPr/>
              </p:nvSpPr>
              <p:spPr>
                <a:xfrm>
                  <a:off x="8088839" y="4840697"/>
                  <a:ext cx="40107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dirty="0"/>
                    <a:t>200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9F31E1D3-6268-4518-83CF-9A01B23BCAEF}"/>
                    </a:ext>
                  </a:extLst>
                </p:cNvPr>
                <p:cNvSpPr txBox="1"/>
                <p:nvPr/>
              </p:nvSpPr>
              <p:spPr>
                <a:xfrm>
                  <a:off x="9009087" y="4840697"/>
                  <a:ext cx="40107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dirty="0"/>
                    <a:t>300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14D81AAC-9A0E-4FBC-9977-3036C644BCA1}"/>
                    </a:ext>
                  </a:extLst>
                </p:cNvPr>
                <p:cNvSpPr txBox="1"/>
                <p:nvPr/>
              </p:nvSpPr>
              <p:spPr>
                <a:xfrm>
                  <a:off x="9929335" y="4840697"/>
                  <a:ext cx="40107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dirty="0"/>
                    <a:t>400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AEEE6B60-CC7E-4C8E-B8EC-E48146933B4A}"/>
                    </a:ext>
                  </a:extLst>
                </p:cNvPr>
                <p:cNvSpPr txBox="1"/>
                <p:nvPr/>
              </p:nvSpPr>
              <p:spPr>
                <a:xfrm>
                  <a:off x="6411038" y="4840697"/>
                  <a:ext cx="25680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dirty="0"/>
                    <a:t>0</a:t>
                  </a:r>
                </a:p>
              </p:txBody>
            </p:sp>
          </p:grp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E6D5CD61-A6D5-465B-99A9-41C74AB44946}"/>
                  </a:ext>
                </a:extLst>
              </p:cNvPr>
              <p:cNvGrpSpPr/>
              <p:nvPr/>
            </p:nvGrpSpPr>
            <p:grpSpPr>
              <a:xfrm>
                <a:off x="938975" y="2214998"/>
                <a:ext cx="305193" cy="1494783"/>
                <a:chOff x="200028" y="1097244"/>
                <a:chExt cx="348172" cy="1574668"/>
              </a:xfrm>
            </p:grpSpPr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EAF1F2B9-780C-400A-93E3-2DBDE59962BB}"/>
                    </a:ext>
                  </a:extLst>
                </p:cNvPr>
                <p:cNvSpPr txBox="1"/>
                <p:nvPr/>
              </p:nvSpPr>
              <p:spPr>
                <a:xfrm>
                  <a:off x="200028" y="1429356"/>
                  <a:ext cx="34817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/>
                    <a:t>0.6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2C47CD0A-AB26-4C6D-84BA-89ABCB8E1432}"/>
                    </a:ext>
                  </a:extLst>
                </p:cNvPr>
                <p:cNvSpPr txBox="1"/>
                <p:nvPr/>
              </p:nvSpPr>
              <p:spPr>
                <a:xfrm>
                  <a:off x="200028" y="1761468"/>
                  <a:ext cx="34817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/>
                    <a:t>0.4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B885E4B8-D300-427A-883B-F4E43845052A}"/>
                    </a:ext>
                  </a:extLst>
                </p:cNvPr>
                <p:cNvSpPr txBox="1"/>
                <p:nvPr/>
              </p:nvSpPr>
              <p:spPr>
                <a:xfrm>
                  <a:off x="200028" y="2093580"/>
                  <a:ext cx="34817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/>
                    <a:t>0.2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7C68A123-D7C1-4BBB-961B-557E0CA0248F}"/>
                    </a:ext>
                  </a:extLst>
                </p:cNvPr>
                <p:cNvSpPr txBox="1"/>
                <p:nvPr/>
              </p:nvSpPr>
              <p:spPr>
                <a:xfrm>
                  <a:off x="297810" y="242569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/>
                    <a:t>0</a:t>
                  </a:r>
                </a:p>
              </p:txBody>
            </p: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C22B616A-E448-4640-AD5B-AC1201F8B0CD}"/>
                    </a:ext>
                  </a:extLst>
                </p:cNvPr>
                <p:cNvSpPr txBox="1"/>
                <p:nvPr/>
              </p:nvSpPr>
              <p:spPr>
                <a:xfrm>
                  <a:off x="200028" y="1097244"/>
                  <a:ext cx="34817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/>
                    <a:t>0.8</a:t>
                  </a:r>
                </a:p>
              </p:txBody>
            </p: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D8DD73BF-8F37-484C-891E-E21EADD8960C}"/>
                  </a:ext>
                </a:extLst>
              </p:cNvPr>
              <p:cNvSpPr txBox="1"/>
              <p:nvPr/>
            </p:nvSpPr>
            <p:spPr>
              <a:xfrm rot="16200000">
                <a:off x="140088" y="2770431"/>
                <a:ext cx="1417780" cy="2428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Absorbance (360nm)</a:t>
                </a:r>
              </a:p>
            </p:txBody>
          </p:sp>
        </p:grp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8E214D7-4E00-99BF-D32E-71560044778D}"/>
              </a:ext>
            </a:extLst>
          </p:cNvPr>
          <p:cNvSpPr txBox="1"/>
          <p:nvPr/>
        </p:nvSpPr>
        <p:spPr>
          <a:xfrm>
            <a:off x="2082826" y="4997063"/>
            <a:ext cx="8363444" cy="17747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8.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PlexinB1 and PlexinB2 GAP activity for Ran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ssociated with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gure 5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andard curve of absorbance at 360nm against concentration of inorganic phosphate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using the MESG/PNP-photometric assay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).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presentative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omassie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stained gel of purified cytoPlexinB1(WT), cytoPlexinB1(RA) cytoPlexinB2, cytoPlexinB3,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AP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nd Ran proteins used in the GAP assays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).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ependence of the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AP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ctivity on Ran protein concentration, using 60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 PlexinB2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nd indicated </a:t>
            </a:r>
            <a:r>
              <a:rPr lang="en-GB" sz="1200" kern="12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concentrations.  Values in the absence of Ran and Plexin were subtracted for each time point to control for a slow increase in absorbance at 360nm due to the spontaneous conversion of MESG.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850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44:47Z</dcterms:created>
  <dcterms:modified xsi:type="dcterms:W3CDTF">2023-06-02T16:45:41Z</dcterms:modified>
</cp:coreProperties>
</file>